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84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yman Haq" userId="a399cf846fb79993" providerId="LiveId" clId="{8630EA95-5E16-4499-AC20-83F858E2ED4B}"/>
    <pc:docChg chg="delSld">
      <pc:chgData name="Ayman Haq" userId="a399cf846fb79993" providerId="LiveId" clId="{8630EA95-5E16-4499-AC20-83F858E2ED4B}" dt="2023-08-23T04:43:18.539" v="0" actId="47"/>
      <pc:docMkLst>
        <pc:docMk/>
      </pc:docMkLst>
      <pc:sldChg chg="del">
        <pc:chgData name="Ayman Haq" userId="a399cf846fb79993" providerId="LiveId" clId="{8630EA95-5E16-4499-AC20-83F858E2ED4B}" dt="2023-08-23T04:43:18.539" v="0" actId="47"/>
        <pc:sldMkLst>
          <pc:docMk/>
          <pc:sldMk cId="3656915007" sldId="257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1249997958" sldId="258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3615506138" sldId="260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1591925606" sldId="261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2880646474" sldId="262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4101996055" sldId="264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2642713466" sldId="265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115430963" sldId="266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3949908288" sldId="267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1178009231" sldId="268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966335345" sldId="269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1439227416" sldId="270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3429095083" sldId="271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394390224" sldId="272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2228847554" sldId="273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2914952017" sldId="274"/>
        </pc:sldMkLst>
      </pc:sldChg>
      <pc:sldChg chg="del">
        <pc:chgData name="Ayman Haq" userId="a399cf846fb79993" providerId="LiveId" clId="{8630EA95-5E16-4499-AC20-83F858E2ED4B}" dt="2023-08-23T04:43:18.539" v="0" actId="47"/>
        <pc:sldMkLst>
          <pc:docMk/>
          <pc:sldMk cId="125521327" sldId="27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3669AC-0465-E54D-8B3C-F61CDBF68585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92BFC4-36EA-874F-A76B-118B566ED7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0457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C5C201-4F4F-95B0-7893-158820B6A8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A337C41-9178-B3DA-6A0E-630218A00A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A2856D-C295-BCA9-E7BD-8F6CA3D4A3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912B4A-1F08-A127-991A-B92444E2D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1176CD-B831-0CAE-2876-E88F9AC2C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227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18C839-220C-342E-B9D3-1AD9BDCB3D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C6FE2B-8EC2-2A75-5F07-1D19E7D862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8D3618-729B-EC39-2B01-4AF32AA85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CC6A14-B2A7-9FE7-159C-81B6EA801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C92F80-BF0A-698A-499D-C002FE44A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962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35D6A5-957A-5AE0-3F3A-6642FE69D7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DF5CA0-EABA-1E04-6928-4CE3E610EB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5DB407-2247-90E0-5DE1-02AEF10A0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56222A-1846-6C89-D6A0-24A3875CE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C78B8D-4B27-D9B8-C475-F6CF9B3EC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10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6D9F8F-B254-31C5-777E-CFF33E0D6D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7D09F5-E553-8A4F-6442-A333545134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DC797B-7858-D874-7934-56514B1BF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CD9274-060B-4531-40E1-AE81DF715F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F1E3CA-C3EC-9EBA-2B11-FAEAF3BE6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080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8C338A-E70B-D5BB-25CC-21F610497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827C34-C8C9-BD87-8069-B71BF5EBB0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BA58DA-F8F7-5C59-7D1E-0F014E59E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E344EB-B7E0-BC84-0705-5A23BF67C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8332B5-6204-4337-7383-BB0B41E5A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464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35562-54B8-3585-0103-ACDE2EDB62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2183DB-1B46-3B47-1C4E-E9D202B615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51187F-759F-D5DD-DB4A-3387F5AFA2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C3EF96-BC8C-AB91-BD27-5313A4AB4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3DDA8C-2E4E-3CB5-2734-DB9E0E7FC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89876E-50E2-83A1-7AB3-1DE1F855F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9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33AE1-A982-A698-1A4F-2FB1E55E63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25CBC1-98F1-CA5E-2B32-527598BD3B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0003A6-51E8-3A4E-3835-9BFE9E3D49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2E9201-A205-06ED-DC55-30513B4552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2821E3-73CB-F3A3-EB24-18144B9B8F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D84A90-1461-BFC6-9148-8A557CA70C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814F21-9EF6-F401-946A-B2DD8B54B3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EEF16C-BAD3-6532-1451-7AD4D1F87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003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415F3E-A9E2-2F29-6391-A6B3EDC8B8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5CEF3F-5EAA-289E-B1F1-49751BF3B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0FAFA6-9612-0D07-84AA-78E34DEBE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41EAE1-A577-187D-10CE-58392A31E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471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B27A502-7D90-1526-ECC7-E74E3E686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089B7A-32B3-7B20-6D25-CFF93437E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CA8203C-11F2-0CE2-3C47-1362DD0ED8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473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FCF19-4CC2-35FB-40ED-E6690B73E1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D9AE8E-BA15-2081-06B5-BAF0F3A003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1C711B-882B-840A-F8A3-8226D46738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B88A1A-CAE8-2CF1-BC35-EBD7DD125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2B9F48-22F1-BE87-F77A-8C6F33C6D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54207B-D0D2-B209-B1B6-ADF2065D5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387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6E1E64-C60A-B5B1-E771-35DCE2740C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63B643E-D402-EA83-E0C7-65F7B6D4A2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330F3C-AC21-AEF3-561F-0E6DC417AC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73E6D4-0E8E-34CD-555E-BE5774C75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667F16-E547-05CA-6666-1675650B8B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DD0C39-197B-D96C-E8CB-4F6227682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806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3074892-1A3C-E564-06FB-E94292DCF3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FBAC84-A396-84AC-79BD-0F2F210B98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7609D-D886-2ED3-A213-955D78C2AF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IE"/>
              <a:t>7/25/23</a:t>
            </a: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BBDF68-9FA2-DD35-BD72-54B9864F1A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0BE31B-F5E4-94B1-204F-64490E9E7A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8B5706-7F36-0247-ADDD-37BA7A88B9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827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B61E92C8-DF1A-1792-0ED6-3DB3922AA20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37"/>
          <a:stretch/>
        </p:blipFill>
        <p:spPr bwMode="auto">
          <a:xfrm>
            <a:off x="1709739" y="1788021"/>
            <a:ext cx="9144000" cy="50985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Left Bracket 4">
            <a:extLst>
              <a:ext uri="{FF2B5EF4-FFF2-40B4-BE49-F238E27FC236}">
                <a16:creationId xmlns:a16="http://schemas.microsoft.com/office/drawing/2014/main" id="{EA6B6B7F-B29F-5CEF-8CC4-F118A13C4772}"/>
              </a:ext>
            </a:extLst>
          </p:cNvPr>
          <p:cNvSpPr/>
          <p:nvPr/>
        </p:nvSpPr>
        <p:spPr>
          <a:xfrm rot="5400000">
            <a:off x="4330753" y="563478"/>
            <a:ext cx="120586" cy="2558097"/>
          </a:xfrm>
          <a:prstGeom prst="leftBracket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Left Bracket 5">
            <a:extLst>
              <a:ext uri="{FF2B5EF4-FFF2-40B4-BE49-F238E27FC236}">
                <a16:creationId xmlns:a16="http://schemas.microsoft.com/office/drawing/2014/main" id="{46212E83-8BD9-DA82-EF0E-658C08CECE39}"/>
              </a:ext>
            </a:extLst>
          </p:cNvPr>
          <p:cNvSpPr/>
          <p:nvPr/>
        </p:nvSpPr>
        <p:spPr>
          <a:xfrm rot="5400000">
            <a:off x="6988707" y="831152"/>
            <a:ext cx="120587" cy="2049654"/>
          </a:xfrm>
          <a:prstGeom prst="leftBracket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Left Bracket 6">
            <a:extLst>
              <a:ext uri="{FF2B5EF4-FFF2-40B4-BE49-F238E27FC236}">
                <a16:creationId xmlns:a16="http://schemas.microsoft.com/office/drawing/2014/main" id="{8176D6DE-8883-AB97-3794-0A7D5B303B84}"/>
              </a:ext>
            </a:extLst>
          </p:cNvPr>
          <p:cNvSpPr/>
          <p:nvPr/>
        </p:nvSpPr>
        <p:spPr>
          <a:xfrm rot="5400000">
            <a:off x="5426108" y="-1145820"/>
            <a:ext cx="398653" cy="5604944"/>
          </a:xfrm>
          <a:prstGeom prst="leftBracket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25C10DE-2CA6-6AB6-E43B-5107A4132A60}"/>
              </a:ext>
            </a:extLst>
          </p:cNvPr>
          <p:cNvSpPr txBox="1"/>
          <p:nvPr/>
        </p:nvSpPr>
        <p:spPr>
          <a:xfrm>
            <a:off x="5153189" y="1041956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&lt;0.00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9CEB505-BD7C-6007-E892-7CC754FD80E1}"/>
              </a:ext>
            </a:extLst>
          </p:cNvPr>
          <p:cNvSpPr txBox="1"/>
          <p:nvPr/>
        </p:nvSpPr>
        <p:spPr>
          <a:xfrm>
            <a:off x="3918801" y="1425281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&lt;0.00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53B1150-6CDC-4435-C084-2B2F95D28917}"/>
              </a:ext>
            </a:extLst>
          </p:cNvPr>
          <p:cNvSpPr txBox="1"/>
          <p:nvPr/>
        </p:nvSpPr>
        <p:spPr>
          <a:xfrm>
            <a:off x="6507862" y="1457325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=0.352</a:t>
            </a:r>
          </a:p>
        </p:txBody>
      </p:sp>
      <p:sp>
        <p:nvSpPr>
          <p:cNvPr id="12" name="Date Placeholder 11">
            <a:extLst>
              <a:ext uri="{FF2B5EF4-FFF2-40B4-BE49-F238E27FC236}">
                <a16:creationId xmlns:a16="http://schemas.microsoft.com/office/drawing/2014/main" id="{580A8E55-C414-F578-6C0D-665F0A165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IE"/>
              <a:t>7/25/23</a:t>
            </a:r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EC6831-8BC4-083E-AC4C-289CB798996E}"/>
              </a:ext>
            </a:extLst>
          </p:cNvPr>
          <p:cNvSpPr txBox="1"/>
          <p:nvPr/>
        </p:nvSpPr>
        <p:spPr>
          <a:xfrm>
            <a:off x="707923" y="359302"/>
            <a:ext cx="104615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: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cidence of MACE in STEMI Patients at 12-Month Follow-Up by IMR Thresholds</a:t>
            </a:r>
            <a:endParaRPr lang="en-US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8653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ahom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tsai</dc:creator>
  <cp:lastModifiedBy>Ali Aldujeli</cp:lastModifiedBy>
  <cp:revision>10</cp:revision>
  <dcterms:created xsi:type="dcterms:W3CDTF">2023-07-25T11:22:29Z</dcterms:created>
  <dcterms:modified xsi:type="dcterms:W3CDTF">2023-10-09T12:47:13Z</dcterms:modified>
</cp:coreProperties>
</file>